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78" d="100"/>
          <a:sy n="78" d="100"/>
        </p:scale>
        <p:origin x="725" y="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5/02/2026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43804" y="-103495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400" b="1" dirty="0">
                <a:solidFill>
                  <a:schemeClr val="bg1"/>
                </a:solidFill>
              </a:rPr>
              <a:t>Promoting clinical trials in pediatric IgA nephropathy through extrapolation: an artificial intelligence-enhanced literature review of the disease in pediatrics </a:t>
            </a:r>
            <a:endParaRPr lang="en-GB" sz="24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218760" y="1130650"/>
            <a:ext cx="119732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Assess the similarity in natural history and response to treatment in pediatric versus adult patients with IgA nephropathy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452413" y="1631655"/>
            <a:ext cx="11505934" cy="42473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</a:t>
            </a:r>
            <a:r>
              <a:rPr lang="en-GB" dirty="0">
                <a:solidFill>
                  <a:srgbClr val="0065AA"/>
                </a:solidFill>
              </a:rPr>
              <a:t> </a:t>
            </a:r>
            <a:r>
              <a:rPr lang="en-GB" b="1" dirty="0">
                <a:solidFill>
                  <a:srgbClr val="0065AA"/>
                </a:solidFill>
              </a:rPr>
              <a:t>AND OUTCOMES</a:t>
            </a:r>
          </a:p>
          <a:p>
            <a:r>
              <a:rPr lang="en-US" noProof="0" dirty="0"/>
              <a:t>Literature review of articles about pediatric IgAN published through 2023.</a:t>
            </a:r>
          </a:p>
          <a:p>
            <a:r>
              <a:rPr lang="en-US" noProof="0" dirty="0"/>
              <a:t>Inclusion: (1) Pediatric patients defined as age ≤21 years; and (2) a minimum of 10 patients in the study. </a:t>
            </a:r>
          </a:p>
          <a:p>
            <a:r>
              <a:rPr lang="en-US" noProof="0" dirty="0"/>
              <a:t>Exclusion: (1) Inability to analyze pediatric patients separately in combined study; (2) IgAN not reported as a separate entity; (3) sample size less than 10; (4) clinical studies in which treatments were not randomly assigned or where outcomes were analyzed retrospectively; (5) articles that focused on IgA vasculitis; and (6) case reports, review articles.  </a:t>
            </a:r>
          </a:p>
          <a:p>
            <a:r>
              <a:rPr lang="en-US" noProof="0" dirty="0"/>
              <a:t>Three broad areas: (1) epidemiology and natural history; (2) clinical trials; and (3) biomarkers. </a:t>
            </a:r>
          </a:p>
          <a:p>
            <a:r>
              <a:rPr lang="en-US" noProof="0" dirty="0"/>
              <a:t>Distiller SR</a:t>
            </a:r>
            <a:r>
              <a:rPr lang="en-US" baseline="30000" noProof="0" dirty="0"/>
              <a:t>®</a:t>
            </a:r>
            <a:r>
              <a:rPr lang="en-US" noProof="0" dirty="0"/>
              <a:t> software used to identify relevant articles.</a:t>
            </a:r>
          </a:p>
          <a:p>
            <a:r>
              <a:rPr lang="en-US" noProof="0" dirty="0"/>
              <a:t>Elicit</a:t>
            </a:r>
            <a:r>
              <a:rPr lang="en-US" baseline="30000" noProof="0" dirty="0"/>
              <a:t>®</a:t>
            </a:r>
            <a:r>
              <a:rPr lang="en-US" noProof="0" dirty="0"/>
              <a:t>, an artificial intelligence tool to extract content.</a:t>
            </a:r>
          </a:p>
          <a:p>
            <a:endParaRPr lang="en-US" noProof="0" dirty="0"/>
          </a:p>
          <a:p>
            <a:r>
              <a:rPr lang="en-US" noProof="0" dirty="0"/>
              <a:t>83 articles were reviewed. The clinical trial reports (n=9) and biomarker studies (n=33) were limited in scope. </a:t>
            </a:r>
          </a:p>
          <a:p>
            <a:r>
              <a:rPr lang="en-US" noProof="0" dirty="0"/>
              <a:t>The natural history and epidemiology articles (n=41) suggested that the severity of kidney histopathology at the time of diagnosis indicated a higher risk of disease progression while proteinuria &lt;0.5-1 mg/mg creatinine was associated with a more favorable prognosis. </a:t>
            </a:r>
          </a:p>
          <a:p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Selewski et al. 2026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27350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Proteinuria &gt;0.5-1 and  severity of histopathology are indicative of pediatric patients with IgAN at high risk of progression. Extrapolation may be feasible in this population. AI is a useful tool to facilitate literature reviews.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</TotalTime>
  <Words>317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Howard</dc:creator>
  <cp:lastModifiedBy>Bob Thompson</cp:lastModifiedBy>
  <cp:revision>67</cp:revision>
  <dcterms:created xsi:type="dcterms:W3CDTF">2019-06-13T12:30:18Z</dcterms:created>
  <dcterms:modified xsi:type="dcterms:W3CDTF">2026-02-25T23:35:46Z</dcterms:modified>
</cp:coreProperties>
</file>